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3" r:id="rId7"/>
    <p:sldId id="264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84" d="100"/>
          <a:sy n="84" d="100"/>
        </p:scale>
        <p:origin x="821" y="6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5B9D5A-A882-5A1A-4EAF-767FA6D0A09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B6EECE2-9355-12A8-F4B6-2E1EB3D1945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BB5889-7E5E-95A9-D53C-29F04B7198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0CF96-D835-492D-A5FE-855DDA344BD3}" type="datetimeFigureOut">
              <a:rPr lang="en-US" smtClean="0"/>
              <a:t>6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536A7B-8DF1-70BD-2EB0-10D74DDA02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B4D2DF-A55F-0B4C-2A92-01E25DF1E8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5F645-78D3-43EC-9220-C928F045EA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98300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C86C93-7514-6DE2-6F03-2575CCE0A5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5A1C9EC-9E0D-E159-1EC2-237320C9CDA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77287F-4BFA-0635-2A95-03BE3D27BC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0CF96-D835-492D-A5FE-855DDA344BD3}" type="datetimeFigureOut">
              <a:rPr lang="en-US" smtClean="0"/>
              <a:t>6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DDB40D-4C06-2720-8E4B-A5A07DDDFA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AF29DB-629F-5EC1-3874-2633F8D80A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5F645-78D3-43EC-9220-C928F045EA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5326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0EC16F1-AA79-F7C6-6C56-4CA8980296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1A86F03-3FE9-8A8F-0AAB-A2ECE344E0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9ACB87-5EC8-A1E1-D0C3-EC28AC05FC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0CF96-D835-492D-A5FE-855DDA344BD3}" type="datetimeFigureOut">
              <a:rPr lang="en-US" smtClean="0"/>
              <a:t>6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A81CF4-AE5B-474C-4AA6-02F6EE3C17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0D6EB6-76BF-81B9-77DA-920D00FFA1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5F645-78D3-43EC-9220-C928F045EA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9292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BC6FF0-0F62-5B00-BE95-37167F25C3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CD6CE21-F804-2AB1-6E79-FDBE936D28D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2D5403-4AEF-5B73-0C1E-E4224284BA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0CF96-D835-492D-A5FE-855DDA344BD3}" type="datetimeFigureOut">
              <a:rPr lang="en-US" smtClean="0"/>
              <a:t>6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917130-4BFF-537E-9A90-CD587C1ECC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8E7CB2-18A9-5432-E1AD-0F769B2D59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5F645-78D3-43EC-9220-C928F045EA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71814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C8B43B-E985-5F78-CB5D-73D941ADC8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9B8154-A3AB-75D2-5AD9-D586033E1B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98CA7A-65BD-4449-F668-63EFE026BD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0CF96-D835-492D-A5FE-855DDA344BD3}" type="datetimeFigureOut">
              <a:rPr lang="en-US" smtClean="0"/>
              <a:t>6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2F705A-4346-0D0D-97A6-8B946ED334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DA3B8F-7B0B-E7A4-A5B4-BFCB7A2A90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5F645-78D3-43EC-9220-C928F045EA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24433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FC7C94-C553-EB91-0224-ED58565BCE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3FA733-0FB9-221F-6B55-EF1106155F3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EBE37C2-9732-DB37-B6E3-0DC731A280B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1845AAA-642B-6064-D403-8D9284C8F4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0CF96-D835-492D-A5FE-855DDA344BD3}" type="datetimeFigureOut">
              <a:rPr lang="en-US" smtClean="0"/>
              <a:t>6/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84EB208-83C0-EC73-8451-D445A7F314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1BAFF1D-6874-E007-6188-2222F99AA5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5F645-78D3-43EC-9220-C928F045EA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58639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2694F2-FCAA-EB4A-B022-DCA48C5D2F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7AED1E-F39A-C03B-E31D-57F6D8C3BD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CC16A69-B0A4-8E2F-7799-1C416C6523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9CC428D-D8C6-D1CA-0200-F18EEBCC94F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14ECA35-4D67-D80E-0B26-C99CF103804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143C08D-2367-46CE-67E0-4A72F3505D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0CF96-D835-492D-A5FE-855DDA344BD3}" type="datetimeFigureOut">
              <a:rPr lang="en-US" smtClean="0"/>
              <a:t>6/2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A16E1B9-4602-CEFE-BEB1-F6A2574DEB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7A9E2A1-BF2D-E1DA-AC78-6C302BC2F6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5F645-78D3-43EC-9220-C928F045EA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45724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89C400-0E21-9ACB-2960-DB37D56D34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93425DA-F8B1-AF9F-70EA-E48ECF213F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0CF96-D835-492D-A5FE-855DDA344BD3}" type="datetimeFigureOut">
              <a:rPr lang="en-US" smtClean="0"/>
              <a:t>6/2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5D7046F-1B99-647A-0593-DBE7682017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9EE22E5-E044-4B03-E5CA-71D649B8E8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5F645-78D3-43EC-9220-C928F045EA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0556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3FE9E20-CB43-0551-6752-5188C1E018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0CF96-D835-492D-A5FE-855DDA344BD3}" type="datetimeFigureOut">
              <a:rPr lang="en-US" smtClean="0"/>
              <a:t>6/2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381EB0B-573E-D31E-94D0-70637C6D9D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74633E8-1CA2-9278-8A12-B90D176D1F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5F645-78D3-43EC-9220-C928F045EA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82289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FA87E2-46EE-C13D-CF7A-F3E63932D6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9F8C44C-BB48-35B6-9CE8-6ACF21F3AA6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1CE488D-FBD0-B0DE-D7EE-D9399E6998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8D58009-EDFA-6231-50FB-141AFD0058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0CF96-D835-492D-A5FE-855DDA344BD3}" type="datetimeFigureOut">
              <a:rPr lang="en-US" smtClean="0"/>
              <a:t>6/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3F7A73-C1AF-E2DC-DC47-9DD88F62B6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5E86079-B71E-1998-EC17-D962DC5F85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5F645-78D3-43EC-9220-C928F045EA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33274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B43079-06F6-A43A-4201-149EF65C3E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377A5FA-8355-AE14-F2EB-6329B9A0BF9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450BEDD-0520-6D45-9D2C-57E8C0AFA0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66FF6BB-5E7F-5537-DB38-59CD72B9D1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0CF96-D835-492D-A5FE-855DDA344BD3}" type="datetimeFigureOut">
              <a:rPr lang="en-US" smtClean="0"/>
              <a:t>6/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F41658-4B41-C273-D34C-26FB8ABE4C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58C8FA7-8325-1243-A8EB-8C4DC38DEA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5F645-78D3-43EC-9220-C928F045EA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24944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8586002-F0FE-3320-AF54-2BA6606548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1A9AFEC-3C67-8563-2EA0-B089979FB6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E1B9C5-E666-A3CD-396A-BEBF35DF91E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E80CF96-D835-492D-A5FE-855DDA344BD3}" type="datetimeFigureOut">
              <a:rPr lang="en-US" smtClean="0"/>
              <a:t>6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8031CD-225B-0ED0-3E58-C64853C1185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6A977D-0E24-2D83-24A8-81A1F07F0A0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4F5F645-78D3-43EC-9220-C928F045EA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938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4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4.mp4"/><Relationship Id="rId1" Type="http://schemas.microsoft.com/office/2007/relationships/media" Target="../media/media4.mp4"/><Relationship Id="rId4" Type="http://schemas.openxmlformats.org/officeDocument/2006/relationships/image" Target="../media/image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5.mp4"/><Relationship Id="rId1" Type="http://schemas.microsoft.com/office/2007/relationships/media" Target="../media/media5.mp4"/><Relationship Id="rId4" Type="http://schemas.openxmlformats.org/officeDocument/2006/relationships/image" Target="../media/image5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6.mp4"/><Relationship Id="rId1" Type="http://schemas.microsoft.com/office/2007/relationships/media" Target="../media/media6.mp4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207C95-C9C9-C444-3F6C-1ECAF62142F9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AU" sz="2800" b="1" kern="100" dirty="0">
                <a:effectLst/>
                <a:latin typeface="Minion Pro" panose="02040503050201020203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DNA Partitioning Modulates Liquid-to-Solid Transitions and the Internal Microstructure of FUS Condensates</a:t>
            </a:r>
            <a:endParaRPr lang="en-US" sz="8000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FEEC198-B9F3-0FB5-9A96-57982F061CC4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>
                <a:latin typeface="Minion Pro" panose="02040503050201020203" pitchFamily="18" charset="0"/>
              </a:rPr>
              <a:t>Supplementary Videos</a:t>
            </a:r>
          </a:p>
        </p:txBody>
      </p:sp>
    </p:spTree>
    <p:extLst>
      <p:ext uri="{BB962C8B-B14F-4D97-AF65-F5344CB8AC3E}">
        <p14:creationId xmlns:p14="http://schemas.microsoft.com/office/powerpoint/2010/main" val="18648665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2EE2E2-1617-1C05-55FC-C7DEAC1637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latin typeface="Minion Pro" panose="02040503050201020203" pitchFamily="18" charset="0"/>
              </a:rPr>
              <a:t>Supplementary Video 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126664A-2759-BC4E-F54A-B5C287D55AF1}"/>
              </a:ext>
            </a:extLst>
          </p:cNvPr>
          <p:cNvSpPr txBox="1"/>
          <p:nvPr/>
        </p:nvSpPr>
        <p:spPr>
          <a:xfrm>
            <a:off x="152400" y="5783056"/>
            <a:ext cx="11887200" cy="97661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Aft>
                <a:spcPts val="800"/>
              </a:spcAft>
              <a:buNone/>
            </a:pPr>
            <a:r>
              <a:rPr lang="en-AU" sz="1800" b="1" kern="100" dirty="0">
                <a:effectLst/>
                <a:latin typeface="Minion Pro" panose="02040503050201020203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Video 1 Supplementary Video 1. Dissolution of freshly formed FUS condensates upon addition of 100 </a:t>
            </a:r>
            <a:r>
              <a:rPr lang="en-AU" sz="1800" b="1" kern="100" dirty="0" err="1">
                <a:effectLst/>
                <a:latin typeface="Minion Pro" panose="02040503050201020203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nM</a:t>
            </a:r>
            <a:r>
              <a:rPr lang="en-AU" sz="1800" b="1" kern="100" dirty="0">
                <a:effectLst/>
                <a:latin typeface="Minion Pro" panose="02040503050201020203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DNA. Green: FUS; Yellow: DNA. DNA rapidly partitions into the condensates, leading to their dissolution over time. </a:t>
            </a:r>
            <a:endParaRPr lang="en-US" sz="1800" kern="100" dirty="0">
              <a:effectLst/>
              <a:latin typeface="Minion Pro" panose="02040503050201020203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8" name="000 Supplementary Video 1">
            <a:hlinkClick r:id="" action="ppaction://media"/>
            <a:extLst>
              <a:ext uri="{FF2B5EF4-FFF2-40B4-BE49-F238E27FC236}">
                <a16:creationId xmlns:a16="http://schemas.microsoft.com/office/drawing/2014/main" id="{C2E81D6A-C695-C33B-A1A0-4436517B5B76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951356" y="1546501"/>
            <a:ext cx="4070350" cy="40703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9472027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1100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8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1DE8FFB-8778-9332-F3FB-85130ADD308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B04167-4378-C9F4-C71A-3DF0594F06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ry Video 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512655B-5847-4CF1-D44B-E79F9D6275FB}"/>
              </a:ext>
            </a:extLst>
          </p:cNvPr>
          <p:cNvSpPr txBox="1"/>
          <p:nvPr/>
        </p:nvSpPr>
        <p:spPr>
          <a:xfrm>
            <a:off x="133350" y="6000273"/>
            <a:ext cx="12058650" cy="6802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AU" b="1" kern="100" dirty="0">
                <a:latin typeface="Minion Pro" panose="02040503050201020203" pitchFamily="18" charset="0"/>
                <a:cs typeface="Times New Roman" panose="02020603050405020304" pitchFamily="18" charset="0"/>
              </a:rPr>
              <a:t>Supplementary Video 2 </a:t>
            </a:r>
            <a:r>
              <a:rPr lang="en-US" b="1" kern="100" dirty="0">
                <a:latin typeface="Minion Pro" panose="02040503050201020203" pitchFamily="18" charset="0"/>
                <a:cs typeface="Times New Roman" panose="02020603050405020304" pitchFamily="18" charset="0"/>
              </a:rPr>
              <a:t>DNA partitioning into 5hr-FUS condensates. The video shows DNA entering from the condensate interface toward the core, without subsequent dissolution. </a:t>
            </a:r>
            <a:r>
              <a:rPr lang="en-AU" sz="1800" b="1" kern="100" dirty="0">
                <a:effectLst/>
                <a:latin typeface="Minion Pro" panose="02040503050201020203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Green: FUS; Yellow: DNA. </a:t>
            </a:r>
            <a:endParaRPr lang="en-US" b="1" kern="100" dirty="0">
              <a:latin typeface="Minion Pro" panose="02040503050201020203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000 Supplementary Video 2">
            <a:hlinkClick r:id="" action="ppaction://media"/>
            <a:extLst>
              <a:ext uri="{FF2B5EF4-FFF2-40B4-BE49-F238E27FC236}">
                <a16:creationId xmlns:a16="http://schemas.microsoft.com/office/drawing/2014/main" id="{A6EC6201-49C4-983A-CBF2-6D74FD19189D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870877" y="1545534"/>
            <a:ext cx="4070350" cy="40703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9178592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800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9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4F81F17-08D4-BD52-84B5-7AE5144E42B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4731E5-AD98-B264-A772-DE5BC5E9EA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latin typeface="Minion Pro" panose="02040503050201020203" pitchFamily="18" charset="0"/>
              </a:rPr>
              <a:t>Supplementary Video 3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EFEAE3D-257F-5166-196F-E6F23B41ADE4}"/>
              </a:ext>
            </a:extLst>
          </p:cNvPr>
          <p:cNvSpPr txBox="1"/>
          <p:nvPr/>
        </p:nvSpPr>
        <p:spPr>
          <a:xfrm>
            <a:off x="0" y="5881386"/>
            <a:ext cx="11807687" cy="97661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Aft>
                <a:spcPts val="800"/>
              </a:spcAft>
              <a:buNone/>
            </a:pPr>
            <a:r>
              <a:rPr lang="en-AU" sz="1800" b="1" kern="100" dirty="0">
                <a:effectLst/>
                <a:latin typeface="Minion Pro" panose="02040503050201020203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Video 3 Dissolution of 24hr-FUS-DNA condensate by 1 M KCL. The video is showing release of DNA from FUS condensate back to the dispersed phase with porous core-shell structure remained. Green: FUS; Yellow: DNA. </a:t>
            </a:r>
            <a:endParaRPr lang="en-US" sz="1800" kern="100" dirty="0">
              <a:effectLst/>
              <a:latin typeface="Minion Pro" panose="02040503050201020203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0" name="000 Supplementary Video 3">
            <a:hlinkClick r:id="" action="ppaction://media"/>
            <a:extLst>
              <a:ext uri="{FF2B5EF4-FFF2-40B4-BE49-F238E27FC236}">
                <a16:creationId xmlns:a16="http://schemas.microsoft.com/office/drawing/2014/main" id="{6792AB2F-C6E5-70F9-12FC-C0227D2A67C3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4061734" y="1366913"/>
            <a:ext cx="4068531" cy="41241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116055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800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10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1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0"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4171A0A-909F-DB89-A391-871BF83C89A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586EC3-D485-8A11-3867-90D2F5648B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latin typeface="Minion Pro" panose="02040503050201020203" pitchFamily="18" charset="0"/>
              </a:rPr>
              <a:t>Supplementary Video 4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CDDC8A9-0EB0-77B4-5B99-6DCDE17C2D21}"/>
              </a:ext>
            </a:extLst>
          </p:cNvPr>
          <p:cNvSpPr txBox="1"/>
          <p:nvPr/>
        </p:nvSpPr>
        <p:spPr>
          <a:xfrm>
            <a:off x="97735" y="6046465"/>
            <a:ext cx="11996530" cy="6802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Aft>
                <a:spcPts val="800"/>
              </a:spcAft>
              <a:buNone/>
            </a:pPr>
            <a:r>
              <a:rPr lang="en-AU" sz="1800" b="1" kern="100" dirty="0">
                <a:effectLst/>
                <a:latin typeface="Minion Pro" panose="02040503050201020203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Video 4 Z stack confocal microscopy acquisition of porous core-shell structure from dissolved 24hr-FUS-DNA condensate. Related to Figure 5d. </a:t>
            </a:r>
            <a:endParaRPr lang="en-US" sz="1800" kern="100" dirty="0">
              <a:effectLst/>
              <a:latin typeface="Minion Pro" panose="02040503050201020203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000 Supplementary Video 4">
            <a:hlinkClick r:id="" action="ppaction://media"/>
            <a:extLst>
              <a:ext uri="{FF2B5EF4-FFF2-40B4-BE49-F238E27FC236}">
                <a16:creationId xmlns:a16="http://schemas.microsoft.com/office/drawing/2014/main" id="{2F8C9878-B789-35FD-DEF0-C15DFA757B6F}"/>
              </a:ext>
            </a:extLst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920331" y="1507573"/>
            <a:ext cx="4351338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0810930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60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FA80D43-1FC3-C050-5C6E-3D3ECCD5F27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86EB9E-01F7-D693-6AFC-F7B43AFC04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latin typeface="Minion Pro" panose="02040503050201020203" pitchFamily="18" charset="0"/>
              </a:rPr>
              <a:t>Supplementary Video 5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6BFFF22-76C1-4CDB-4BB2-0EB45F41E90F}"/>
              </a:ext>
            </a:extLst>
          </p:cNvPr>
          <p:cNvSpPr txBox="1"/>
          <p:nvPr/>
        </p:nvSpPr>
        <p:spPr>
          <a:xfrm>
            <a:off x="97735" y="6046465"/>
            <a:ext cx="11996530" cy="6802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Aft>
                <a:spcPts val="800"/>
              </a:spcAft>
              <a:buNone/>
            </a:pPr>
            <a:r>
              <a:rPr lang="en-AU" sz="1800" b="1" kern="100" dirty="0">
                <a:effectLst/>
                <a:latin typeface="Minion Pro" panose="02040503050201020203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Video 4 Z stack confocal microscopy acquisition of porous core-shell structure from dissolved </a:t>
            </a:r>
            <a:r>
              <a:rPr lang="en-AU" b="1" kern="100" dirty="0">
                <a:latin typeface="Minion Pro" panose="02040503050201020203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48</a:t>
            </a:r>
            <a:r>
              <a:rPr lang="en-AU" sz="1800" b="1" kern="100" dirty="0">
                <a:effectLst/>
                <a:latin typeface="Minion Pro" panose="02040503050201020203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r-FUS-DNA condensate. Related to Figure 5d. </a:t>
            </a:r>
            <a:endParaRPr lang="en-US" sz="1800" kern="100" dirty="0">
              <a:effectLst/>
              <a:latin typeface="Minion Pro" panose="02040503050201020203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" name="000 Supplementary Video 5">
            <a:hlinkClick r:id="" action="ppaction://media"/>
            <a:extLst>
              <a:ext uri="{FF2B5EF4-FFF2-40B4-BE49-F238E27FC236}">
                <a16:creationId xmlns:a16="http://schemas.microsoft.com/office/drawing/2014/main" id="{DBB82FDE-6F68-F0FB-3470-F832BB4A58EB}"/>
              </a:ext>
            </a:extLst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920331" y="1517512"/>
            <a:ext cx="4351338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24119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400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5073A84-C88D-421D-E7AE-25BBD71ABD0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7263B0-2C00-320F-4A34-59B6867A8C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latin typeface="Minion Pro" panose="02040503050201020203" pitchFamily="18" charset="0"/>
              </a:rPr>
              <a:t>Supplementary Video 6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27AB8F0-F00B-9C36-FBBE-6F3F4D45BC3E}"/>
              </a:ext>
            </a:extLst>
          </p:cNvPr>
          <p:cNvSpPr txBox="1"/>
          <p:nvPr/>
        </p:nvSpPr>
        <p:spPr>
          <a:xfrm>
            <a:off x="0" y="6066344"/>
            <a:ext cx="11996530" cy="6802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Aft>
                <a:spcPts val="800"/>
              </a:spcAft>
              <a:buNone/>
            </a:pPr>
            <a:r>
              <a:rPr lang="en-AU" sz="1800" b="1" kern="100" dirty="0">
                <a:effectLst/>
                <a:latin typeface="Minion Pro" panose="02040503050201020203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Video 4 Z stack confocal microscopy acquisition of porous core-shell structure from dissolved </a:t>
            </a:r>
            <a:r>
              <a:rPr lang="en-AU" b="1" kern="100" dirty="0">
                <a:latin typeface="Minion Pro" panose="02040503050201020203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1wk</a:t>
            </a:r>
            <a:r>
              <a:rPr lang="en-AU" sz="1800" b="1" kern="100" dirty="0">
                <a:effectLst/>
                <a:latin typeface="Minion Pro" panose="02040503050201020203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-FUS-DNA condensate. Related to Figure 5d. </a:t>
            </a:r>
            <a:endParaRPr lang="en-US" sz="1800" kern="100" dirty="0">
              <a:effectLst/>
              <a:latin typeface="Minion Pro" panose="02040503050201020203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000 Supplementary Video 6">
            <a:hlinkClick r:id="" action="ppaction://media"/>
            <a:extLst>
              <a:ext uri="{FF2B5EF4-FFF2-40B4-BE49-F238E27FC236}">
                <a16:creationId xmlns:a16="http://schemas.microsoft.com/office/drawing/2014/main" id="{BCCE80F5-BC80-144A-6748-A035DE72B629}"/>
              </a:ext>
            </a:extLst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822596" y="1527451"/>
            <a:ext cx="4351338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4967312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200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7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215</Words>
  <Application>Microsoft Office PowerPoint</Application>
  <PresentationFormat>Widescreen</PresentationFormat>
  <Paragraphs>14</Paragraphs>
  <Slides>7</Slides>
  <Notes>0</Notes>
  <HiddenSlides>0</HiddenSlides>
  <MMClips>6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ptos</vt:lpstr>
      <vt:lpstr>Aptos Display</vt:lpstr>
      <vt:lpstr>Arial</vt:lpstr>
      <vt:lpstr>Minion Pro</vt:lpstr>
      <vt:lpstr>Office Theme</vt:lpstr>
      <vt:lpstr>DNA Partitioning Modulates Liquid-to-Solid Transitions and the Internal Microstructure of FUS Condensates</vt:lpstr>
      <vt:lpstr>Supplementary Video 1</vt:lpstr>
      <vt:lpstr>Supplementary Video 2</vt:lpstr>
      <vt:lpstr>Supplementary Video 3</vt:lpstr>
      <vt:lpstr>Supplementary Video 4</vt:lpstr>
      <vt:lpstr>Supplementary Video 5</vt:lpstr>
      <vt:lpstr>Supplementary Video 6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ea Ilhamsyah</dc:creator>
  <cp:lastModifiedBy>Dea Ilhamsyah</cp:lastModifiedBy>
  <cp:revision>6</cp:revision>
  <dcterms:created xsi:type="dcterms:W3CDTF">2025-05-29T06:18:18Z</dcterms:created>
  <dcterms:modified xsi:type="dcterms:W3CDTF">2025-06-01T19:04:11Z</dcterms:modified>
</cp:coreProperties>
</file>